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1853273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2857193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2263908" y="128541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>
            <a:cxnSpLocks/>
          </p:cNvCxnSpPr>
          <p:nvPr/>
        </p:nvCxnSpPr>
        <p:spPr>
          <a:xfrm flipV="1">
            <a:off x="1919870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7C3FE91-2135-09BD-D113-D06C24B4C89E}"/>
              </a:ext>
            </a:extLst>
          </p:cNvPr>
          <p:cNvSpPr txBox="1"/>
          <p:nvPr/>
        </p:nvSpPr>
        <p:spPr>
          <a:xfrm rot="16200000">
            <a:off x="738079" y="4570326"/>
            <a:ext cx="1450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errostatin-1</a:t>
            </a:r>
            <a:endParaRPr lang="en-GB" baseline="-25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EA7855-09B2-871C-E479-4DEFF9356B74}"/>
              </a:ext>
            </a:extLst>
          </p:cNvPr>
          <p:cNvSpPr txBox="1"/>
          <p:nvPr/>
        </p:nvSpPr>
        <p:spPr>
          <a:xfrm>
            <a:off x="4304663" y="1285415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SL3ko#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48F5A0E-9778-27D1-5113-E033519FB18D}"/>
              </a:ext>
            </a:extLst>
          </p:cNvPr>
          <p:cNvSpPr txBox="1"/>
          <p:nvPr/>
        </p:nvSpPr>
        <p:spPr>
          <a:xfrm>
            <a:off x="6847001" y="1285415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SL3ko#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C3A37D-D402-4A7A-5514-139877F910ED}"/>
              </a:ext>
            </a:extLst>
          </p:cNvPr>
          <p:cNvSpPr txBox="1"/>
          <p:nvPr/>
        </p:nvSpPr>
        <p:spPr>
          <a:xfrm rot="16200000">
            <a:off x="987956" y="2733938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97BD086-C3D7-F423-3CF6-1F20171D18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7680" y="2067448"/>
            <a:ext cx="905806" cy="3600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46F2001-CD77-5B2D-7783-C25120ED84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2832" y="2084215"/>
            <a:ext cx="905806" cy="36000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518835C-3FAE-29CB-E348-C5E2970A74FB}"/>
              </a:ext>
            </a:extLst>
          </p:cNvPr>
          <p:cNvSpPr txBox="1"/>
          <p:nvPr/>
        </p:nvSpPr>
        <p:spPr>
          <a:xfrm>
            <a:off x="4230974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F4B4F9-A8A5-9C2E-F515-2ABAF5DE7B4E}"/>
              </a:ext>
            </a:extLst>
          </p:cNvPr>
          <p:cNvSpPr txBox="1"/>
          <p:nvPr/>
        </p:nvSpPr>
        <p:spPr>
          <a:xfrm>
            <a:off x="5234894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2630858-0521-E760-9E4B-2D0B60C42C7F}"/>
              </a:ext>
            </a:extLst>
          </p:cNvPr>
          <p:cNvCxnSpPr>
            <a:cxnSpLocks/>
          </p:cNvCxnSpPr>
          <p:nvPr/>
        </p:nvCxnSpPr>
        <p:spPr>
          <a:xfrm flipV="1">
            <a:off x="4297571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F2E841C-088B-9495-E336-04E448D8692B}"/>
              </a:ext>
            </a:extLst>
          </p:cNvPr>
          <p:cNvSpPr txBox="1"/>
          <p:nvPr/>
        </p:nvSpPr>
        <p:spPr>
          <a:xfrm>
            <a:off x="6859479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B3D67A-D25D-1B2C-A27B-0D70E4D4A696}"/>
              </a:ext>
            </a:extLst>
          </p:cNvPr>
          <p:cNvSpPr txBox="1"/>
          <p:nvPr/>
        </p:nvSpPr>
        <p:spPr>
          <a:xfrm>
            <a:off x="7863399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4BF462C-E49D-3898-0205-38891AB4698F}"/>
              </a:ext>
            </a:extLst>
          </p:cNvPr>
          <p:cNvCxnSpPr>
            <a:cxnSpLocks/>
          </p:cNvCxnSpPr>
          <p:nvPr/>
        </p:nvCxnSpPr>
        <p:spPr>
          <a:xfrm flipV="1">
            <a:off x="6926076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9" name="Picture 28">
            <a:extLst>
              <a:ext uri="{FF2B5EF4-FFF2-40B4-BE49-F238E27FC236}">
                <a16:creationId xmlns:a16="http://schemas.microsoft.com/office/drawing/2014/main" id="{CBA3A390-DA09-495B-6B33-E14661C1A2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4048" y="2067448"/>
            <a:ext cx="905806" cy="3600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EA35A90-F1E6-4DFC-7B3E-1EA7672FFB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41086" y="2084215"/>
            <a:ext cx="905806" cy="3600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458C5095-AF72-EC55-C178-E436C40DE0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09870" y="2094877"/>
            <a:ext cx="905806" cy="3600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E33CBB3E-87FA-E888-9942-8A9DE55E131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36003" y="2094877"/>
            <a:ext cx="917647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129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1853273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2857193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2263908" y="128541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>
            <a:cxnSpLocks/>
          </p:cNvCxnSpPr>
          <p:nvPr/>
        </p:nvCxnSpPr>
        <p:spPr>
          <a:xfrm flipV="1">
            <a:off x="1919870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7C3FE91-2135-09BD-D113-D06C24B4C89E}"/>
              </a:ext>
            </a:extLst>
          </p:cNvPr>
          <p:cNvSpPr txBox="1"/>
          <p:nvPr/>
        </p:nvSpPr>
        <p:spPr>
          <a:xfrm rot="16200000">
            <a:off x="738079" y="4570326"/>
            <a:ext cx="1450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errostatin-1</a:t>
            </a:r>
            <a:endParaRPr lang="en-GB" baseline="-25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EA7855-09B2-871C-E479-4DEFF9356B74}"/>
              </a:ext>
            </a:extLst>
          </p:cNvPr>
          <p:cNvSpPr txBox="1"/>
          <p:nvPr/>
        </p:nvSpPr>
        <p:spPr>
          <a:xfrm>
            <a:off x="4304663" y="1285415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SL3ko#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48F5A0E-9778-27D1-5113-E033519FB18D}"/>
              </a:ext>
            </a:extLst>
          </p:cNvPr>
          <p:cNvSpPr txBox="1"/>
          <p:nvPr/>
        </p:nvSpPr>
        <p:spPr>
          <a:xfrm>
            <a:off x="6847001" y="1285415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SL3ko#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C3A37D-D402-4A7A-5514-139877F910ED}"/>
              </a:ext>
            </a:extLst>
          </p:cNvPr>
          <p:cNvSpPr txBox="1"/>
          <p:nvPr/>
        </p:nvSpPr>
        <p:spPr>
          <a:xfrm rot="16200000">
            <a:off x="987956" y="2733938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518835C-3FAE-29CB-E348-C5E2970A74FB}"/>
              </a:ext>
            </a:extLst>
          </p:cNvPr>
          <p:cNvSpPr txBox="1"/>
          <p:nvPr/>
        </p:nvSpPr>
        <p:spPr>
          <a:xfrm>
            <a:off x="4230974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F4B4F9-A8A5-9C2E-F515-2ABAF5DE7B4E}"/>
              </a:ext>
            </a:extLst>
          </p:cNvPr>
          <p:cNvSpPr txBox="1"/>
          <p:nvPr/>
        </p:nvSpPr>
        <p:spPr>
          <a:xfrm>
            <a:off x="5234894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2630858-0521-E760-9E4B-2D0B60C42C7F}"/>
              </a:ext>
            </a:extLst>
          </p:cNvPr>
          <p:cNvCxnSpPr>
            <a:cxnSpLocks/>
          </p:cNvCxnSpPr>
          <p:nvPr/>
        </p:nvCxnSpPr>
        <p:spPr>
          <a:xfrm flipV="1">
            <a:off x="4297571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F2E841C-088B-9495-E336-04E448D8692B}"/>
              </a:ext>
            </a:extLst>
          </p:cNvPr>
          <p:cNvSpPr txBox="1"/>
          <p:nvPr/>
        </p:nvSpPr>
        <p:spPr>
          <a:xfrm>
            <a:off x="6859479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B3D67A-D25D-1B2C-A27B-0D70E4D4A696}"/>
              </a:ext>
            </a:extLst>
          </p:cNvPr>
          <p:cNvSpPr txBox="1"/>
          <p:nvPr/>
        </p:nvSpPr>
        <p:spPr>
          <a:xfrm>
            <a:off x="7863399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4BF462C-E49D-3898-0205-38891AB4698F}"/>
              </a:ext>
            </a:extLst>
          </p:cNvPr>
          <p:cNvCxnSpPr>
            <a:cxnSpLocks/>
          </p:cNvCxnSpPr>
          <p:nvPr/>
        </p:nvCxnSpPr>
        <p:spPr>
          <a:xfrm flipV="1">
            <a:off x="6926076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B69CC70C-FF5D-8716-0B14-7F3E86DB68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4851" y="2094877"/>
            <a:ext cx="1021154" cy="3600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3E93084-AF10-07E8-DEF5-95CB912B55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6525" y="2094877"/>
            <a:ext cx="1021154" cy="36000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11A4F2D3-48BF-9D0C-1D76-88BFD59E9F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05090" y="2094877"/>
            <a:ext cx="1021154" cy="3600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FC26FBCD-6170-C8CD-F414-D256CCF0BCE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5929"/>
          <a:stretch/>
        </p:blipFill>
        <p:spPr>
          <a:xfrm>
            <a:off x="5134226" y="3028334"/>
            <a:ext cx="1021154" cy="266654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7839A5A5-13F8-3E5D-8AB5-C0003D45FEE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5929"/>
          <a:stretch/>
        </p:blipFill>
        <p:spPr>
          <a:xfrm>
            <a:off x="6633595" y="3028335"/>
            <a:ext cx="1021154" cy="2666542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415E63DB-0969-5E0C-2A27-ABD89255418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52196" y="2104859"/>
            <a:ext cx="1021154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5907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1853273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2857193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2263908" y="128541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>
            <a:cxnSpLocks/>
          </p:cNvCxnSpPr>
          <p:nvPr/>
        </p:nvCxnSpPr>
        <p:spPr>
          <a:xfrm flipV="1">
            <a:off x="1919870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7C3FE91-2135-09BD-D113-D06C24B4C89E}"/>
              </a:ext>
            </a:extLst>
          </p:cNvPr>
          <p:cNvSpPr txBox="1"/>
          <p:nvPr/>
        </p:nvSpPr>
        <p:spPr>
          <a:xfrm rot="16200000">
            <a:off x="738079" y="4570326"/>
            <a:ext cx="1450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errostatin-1</a:t>
            </a:r>
            <a:endParaRPr lang="en-GB" baseline="-25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EA7855-09B2-871C-E479-4DEFF9356B74}"/>
              </a:ext>
            </a:extLst>
          </p:cNvPr>
          <p:cNvSpPr txBox="1"/>
          <p:nvPr/>
        </p:nvSpPr>
        <p:spPr>
          <a:xfrm>
            <a:off x="4304663" y="1285415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SL3ko#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48F5A0E-9778-27D1-5113-E033519FB18D}"/>
              </a:ext>
            </a:extLst>
          </p:cNvPr>
          <p:cNvSpPr txBox="1"/>
          <p:nvPr/>
        </p:nvSpPr>
        <p:spPr>
          <a:xfrm>
            <a:off x="6847001" y="1285415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CSL3ko#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C3A37D-D402-4A7A-5514-139877F910ED}"/>
              </a:ext>
            </a:extLst>
          </p:cNvPr>
          <p:cNvSpPr txBox="1"/>
          <p:nvPr/>
        </p:nvSpPr>
        <p:spPr>
          <a:xfrm rot="16200000">
            <a:off x="987956" y="2733938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518835C-3FAE-29CB-E348-C5E2970A74FB}"/>
              </a:ext>
            </a:extLst>
          </p:cNvPr>
          <p:cNvSpPr txBox="1"/>
          <p:nvPr/>
        </p:nvSpPr>
        <p:spPr>
          <a:xfrm>
            <a:off x="4230974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F4B4F9-A8A5-9C2E-F515-2ABAF5DE7B4E}"/>
              </a:ext>
            </a:extLst>
          </p:cNvPr>
          <p:cNvSpPr txBox="1"/>
          <p:nvPr/>
        </p:nvSpPr>
        <p:spPr>
          <a:xfrm>
            <a:off x="5234894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2630858-0521-E760-9E4B-2D0B60C42C7F}"/>
              </a:ext>
            </a:extLst>
          </p:cNvPr>
          <p:cNvCxnSpPr>
            <a:cxnSpLocks/>
          </p:cNvCxnSpPr>
          <p:nvPr/>
        </p:nvCxnSpPr>
        <p:spPr>
          <a:xfrm flipV="1">
            <a:off x="4297571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F2E841C-088B-9495-E336-04E448D8692B}"/>
              </a:ext>
            </a:extLst>
          </p:cNvPr>
          <p:cNvSpPr txBox="1"/>
          <p:nvPr/>
        </p:nvSpPr>
        <p:spPr>
          <a:xfrm>
            <a:off x="6859479" y="169711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B3D67A-D25D-1B2C-A27B-0D70E4D4A696}"/>
              </a:ext>
            </a:extLst>
          </p:cNvPr>
          <p:cNvSpPr txBox="1"/>
          <p:nvPr/>
        </p:nvSpPr>
        <p:spPr>
          <a:xfrm>
            <a:off x="7863399" y="169711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4BF462C-E49D-3898-0205-38891AB4698F}"/>
              </a:ext>
            </a:extLst>
          </p:cNvPr>
          <p:cNvCxnSpPr>
            <a:cxnSpLocks/>
          </p:cNvCxnSpPr>
          <p:nvPr/>
        </p:nvCxnSpPr>
        <p:spPr>
          <a:xfrm flipV="1">
            <a:off x="6926076" y="1668686"/>
            <a:ext cx="13472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471969B4-F7C6-46EA-0D32-944DC14A1C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3443" y="2094877"/>
            <a:ext cx="994286" cy="3600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A94DD6C-F484-999D-CDE6-65E2C1D504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6548" y="2094877"/>
            <a:ext cx="891429" cy="3600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899DF20-97CB-DFB4-4CB9-97E163B70F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4648" y="2094877"/>
            <a:ext cx="891429" cy="360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598F2F0-6E56-325E-DFA8-BE776CC1CD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47033" y="2094877"/>
            <a:ext cx="891429" cy="36000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A3724EC-01B0-A1A0-8A13-0DBED806F21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79515" y="2123147"/>
            <a:ext cx="891429" cy="3600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0EBB799-4135-39F0-7780-7E5B5BDBCA8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62381" y="2123147"/>
            <a:ext cx="891429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7357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7</TotalTime>
  <Words>54</Words>
  <Application>Microsoft Office PowerPoint</Application>
  <PresentationFormat>Widescreen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24</cp:revision>
  <dcterms:created xsi:type="dcterms:W3CDTF">2024-06-06T16:34:22Z</dcterms:created>
  <dcterms:modified xsi:type="dcterms:W3CDTF">2024-06-18T13:18:27Z</dcterms:modified>
</cp:coreProperties>
</file>